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0" r:id="rId2"/>
  </p:sldIdLst>
  <p:sldSz cx="6858000" cy="9906000" type="A4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182" autoAdjust="0"/>
    <p:restoredTop sz="94660"/>
  </p:normalViewPr>
  <p:slideViewPr>
    <p:cSldViewPr snapToGrid="0">
      <p:cViewPr varScale="1">
        <p:scale>
          <a:sx n="87" d="100"/>
          <a:sy n="87" d="100"/>
        </p:scale>
        <p:origin x="48" y="5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7391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95525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17044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5863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5287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30585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6222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9266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5841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25703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75418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566A3-BCD4-4779-A082-D5F4268DFB98}" type="datetimeFigureOut">
              <a:rPr lang="ko-KR" altLang="en-US" smtClean="0"/>
              <a:t>2020-02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AE7ED-31F0-49FB-B1D9-4B6C2C9187A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816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0228" y="9072819"/>
            <a:ext cx="2754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/>
              <a:t>Suppl. Figure </a:t>
            </a:r>
            <a:r>
              <a:rPr lang="en-US" altLang="ko-KR" dirty="0" smtClean="0"/>
              <a:t>S4.</a:t>
            </a:r>
            <a:endParaRPr lang="ko-KR" altLang="en-US" dirty="0"/>
          </a:p>
        </p:txBody>
      </p:sp>
      <p:grpSp>
        <p:nvGrpSpPr>
          <p:cNvPr id="15" name="그룹 14"/>
          <p:cNvGrpSpPr/>
          <p:nvPr/>
        </p:nvGrpSpPr>
        <p:grpSpPr>
          <a:xfrm>
            <a:off x="946240" y="777889"/>
            <a:ext cx="4608174" cy="7549272"/>
            <a:chOff x="946240" y="777889"/>
            <a:chExt cx="4608174" cy="7549272"/>
          </a:xfrm>
        </p:grpSpPr>
        <p:grpSp>
          <p:nvGrpSpPr>
            <p:cNvPr id="4" name="그룹 3"/>
            <p:cNvGrpSpPr/>
            <p:nvPr/>
          </p:nvGrpSpPr>
          <p:grpSpPr>
            <a:xfrm>
              <a:off x="946240" y="777889"/>
              <a:ext cx="4489188" cy="3575034"/>
              <a:chOff x="760078" y="777889"/>
              <a:chExt cx="4489188" cy="3575034"/>
            </a:xfrm>
          </p:grpSpPr>
          <p:sp>
            <p:nvSpPr>
              <p:cNvPr id="5" name="TextBox 4"/>
              <p:cNvSpPr txBox="1">
                <a:spLocks noChangeArrowheads="1"/>
              </p:cNvSpPr>
              <p:nvPr/>
            </p:nvSpPr>
            <p:spPr bwMode="auto">
              <a:xfrm>
                <a:off x="2161254" y="4045146"/>
                <a:ext cx="291097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ko-KR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 of bevacizumab</a:t>
                </a:r>
                <a:endParaRPr lang="ko-KR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TextBox 3"/>
              <p:cNvSpPr txBox="1">
                <a:spLocks noChangeArrowheads="1"/>
              </p:cNvSpPr>
              <p:nvPr/>
            </p:nvSpPr>
            <p:spPr bwMode="auto">
              <a:xfrm rot="16200000">
                <a:off x="106766" y="2282233"/>
                <a:ext cx="236337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viability (r</a:t>
                </a:r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lative %)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31"/>
              <p:cNvSpPr txBox="1">
                <a:spLocks noChangeArrowheads="1"/>
              </p:cNvSpPr>
              <p:nvPr/>
            </p:nvSpPr>
            <p:spPr bwMode="auto">
              <a:xfrm>
                <a:off x="760078" y="777889"/>
                <a:ext cx="457200" cy="4000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ko-KR" sz="2000" b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ko-KR" altLang="en-US" sz="20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8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301327282"/>
                  </p:ext>
                </p:extLst>
              </p:nvPr>
            </p:nvGraphicFramePr>
            <p:xfrm>
              <a:off x="1355778" y="1031165"/>
              <a:ext cx="3893488" cy="308932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90" name="SPW 11.0 Graph" r:id="rId3" imgW="5241960" imgH="4158720" progId="SigmaPlotGraphicObject.10">
                      <p:embed/>
                    </p:oleObj>
                  </mc:Choice>
                  <mc:Fallback>
                    <p:oleObj name="SPW 11.0 Graph" r:id="rId3" imgW="5241960" imgH="4158720" progId="SigmaPlotGraphicObject.10">
                      <p:embed/>
                      <p:pic>
                        <p:nvPicPr>
                          <p:cNvPr id="4" name="Object 2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355778" y="1031165"/>
                            <a:ext cx="3893488" cy="3089321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grpSp>
          <p:nvGrpSpPr>
            <p:cNvPr id="2" name="그룹 1"/>
            <p:cNvGrpSpPr/>
            <p:nvPr/>
          </p:nvGrpSpPr>
          <p:grpSpPr>
            <a:xfrm>
              <a:off x="950807" y="4752127"/>
              <a:ext cx="4603607" cy="3575034"/>
              <a:chOff x="764645" y="4752127"/>
              <a:chExt cx="4603607" cy="3575034"/>
            </a:xfrm>
          </p:grpSpPr>
          <p:graphicFrame>
            <p:nvGraphicFramePr>
              <p:cNvPr id="14" name="Object 2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52503686"/>
                  </p:ext>
                </p:extLst>
              </p:nvPr>
            </p:nvGraphicFramePr>
            <p:xfrm>
              <a:off x="1370616" y="4974082"/>
              <a:ext cx="3997636" cy="317195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91" name="SPW 11.0 Graph" r:id="rId5" imgW="5241960" imgH="4158720" progId="SigmaPlotGraphicObject.10">
                      <p:embed/>
                    </p:oleObj>
                  </mc:Choice>
                  <mc:Fallback>
                    <p:oleObj name="SPW 11.0 Graph" r:id="rId5" imgW="5241960" imgH="4158720" progId="SigmaPlotGraphicObject.10">
                      <p:embed/>
                      <p:pic>
                        <p:nvPicPr>
                          <p:cNvPr id="5" name="Object 2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6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370616" y="4974082"/>
                            <a:ext cx="3997636" cy="3171958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0" name="TextBox 9"/>
              <p:cNvSpPr txBox="1">
                <a:spLocks noChangeArrowheads="1"/>
              </p:cNvSpPr>
              <p:nvPr/>
            </p:nvSpPr>
            <p:spPr bwMode="auto">
              <a:xfrm>
                <a:off x="2165821" y="8019384"/>
                <a:ext cx="2910978" cy="3077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ko-KR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ncentration of bevacizumab</a:t>
                </a:r>
                <a:endParaRPr lang="ko-KR" alt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3"/>
              <p:cNvSpPr txBox="1">
                <a:spLocks noChangeArrowheads="1"/>
              </p:cNvSpPr>
              <p:nvPr/>
            </p:nvSpPr>
            <p:spPr bwMode="auto">
              <a:xfrm rot="16200000">
                <a:off x="116808" y="6415252"/>
                <a:ext cx="2363375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arasite  viability (r</a:t>
                </a:r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lative %)</a:t>
                </a:r>
                <a:endParaRPr lang="ko-KR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31"/>
              <p:cNvSpPr txBox="1">
                <a:spLocks noChangeArrowheads="1"/>
              </p:cNvSpPr>
              <p:nvPr/>
            </p:nvSpPr>
            <p:spPr bwMode="auto">
              <a:xfrm>
                <a:off x="764645" y="4752127"/>
                <a:ext cx="457200" cy="400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en-US" altLang="ko-KR" sz="2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ko-KR" altLang="en-US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645486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7</TotalTime>
  <Words>23</Words>
  <Application>Microsoft Office PowerPoint</Application>
  <PresentationFormat>A4 용지(210x297mm)</PresentationFormat>
  <Paragraphs>7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Arial</vt:lpstr>
      <vt:lpstr>Calibri</vt:lpstr>
      <vt:lpstr>Calibri Light</vt:lpstr>
      <vt:lpstr>Times New Roman</vt:lpstr>
      <vt:lpstr>Office 테마</vt:lpstr>
      <vt:lpstr>SPW 11.0 Graph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Windows User</cp:lastModifiedBy>
  <cp:revision>21</cp:revision>
  <cp:lastPrinted>2020-02-28T08:05:44Z</cp:lastPrinted>
  <dcterms:created xsi:type="dcterms:W3CDTF">2020-02-24T01:31:01Z</dcterms:created>
  <dcterms:modified xsi:type="dcterms:W3CDTF">2020-02-28T09:57:54Z</dcterms:modified>
</cp:coreProperties>
</file>